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06" autoAdjust="0"/>
    <p:restoredTop sz="92671" autoAdjust="0"/>
  </p:normalViewPr>
  <p:slideViewPr>
    <p:cSldViewPr snapToGrid="0">
      <p:cViewPr>
        <p:scale>
          <a:sx n="75" d="100"/>
          <a:sy n="75" d="100"/>
        </p:scale>
        <p:origin x="-1968" y="-81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E6E07D-1E57-4F05-BBE4-D52175200330}" type="datetimeFigureOut">
              <a:rPr lang="en-US" smtClean="0"/>
              <a:t>2/10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15D819-4D7A-46BD-8B54-8A8A799133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573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7449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4579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7336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361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127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749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982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2448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8552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576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8230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CD288-DEBD-4822-9844-43E58947F650}" type="datetimeFigureOut">
              <a:rPr lang="de-DE" smtClean="0"/>
              <a:t>10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52F88-BFAF-427A-AA6A-3EABD3532E5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8259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Inhaltsplatzhalt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46000317"/>
              </p:ext>
            </p:extLst>
          </p:nvPr>
        </p:nvGraphicFramePr>
        <p:xfrm>
          <a:off x="452438" y="778859"/>
          <a:ext cx="11269664" cy="166141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436564"/>
                <a:gridCol w="876300"/>
                <a:gridCol w="995680"/>
                <a:gridCol w="995680"/>
                <a:gridCol w="995680"/>
                <a:gridCol w="995680"/>
                <a:gridCol w="995680"/>
                <a:gridCol w="995680"/>
                <a:gridCol w="995680"/>
                <a:gridCol w="995680"/>
                <a:gridCol w="995680"/>
                <a:gridCol w="995680"/>
              </a:tblGrid>
              <a:tr h="19050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12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ical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pilar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29418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A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A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D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D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D FAC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A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A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D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D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D FAC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4183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CD28 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7 ± 1.19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5 ± 1.15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 ± 0.0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 ± 0.0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47 ± 6.92</a:t>
                      </a:r>
                      <a:endParaRPr lang="de-DE" sz="12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1 ± 0.9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4 ± 1.1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 ± 0.0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 ± 0.0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34 ± 3.37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418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  <a:endParaRPr lang="de-DE" sz="1200" b="1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2 ± 1.76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1 ± 2.59</a:t>
                      </a:r>
                      <a:endParaRPr lang="de-DE" sz="12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 ± 0.0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 ± 0.0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96 ± 6.96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3 ± 1.91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7 ± 1.86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 ± 0.0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 ± 0.03</a:t>
                      </a:r>
                      <a:endParaRPr lang="de-DE" sz="12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83 ± 5.9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4183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m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CD28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4 ± 0.56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7 ± 0.89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 ± 0.0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 ± 0.0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66 ± 4.47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 ± 0.69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9 ± 0.84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 ± 0.0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 ± 0.01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40 ± 4.44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418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  <a:endParaRPr lang="de-DE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 ± 0.27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1 ± 0.37</a:t>
                      </a:r>
                      <a:endParaRPr lang="de-DE" sz="120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 ± 0.0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 ± 0.0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60 ± 3.7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33 ± 0.23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1 ± 0.56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 ± 0.0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 ± 0.02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91 ± 0.67</a:t>
                      </a:r>
                      <a:endParaRPr lang="de-DE" sz="12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452438" y="2831199"/>
            <a:ext cx="10863262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1 Table.</a:t>
            </a:r>
            <a:r>
              <a:rPr kumimoji="0" lang="en-US" altLang="de-DE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kumimoji="0" lang="en-US" altLang="de-D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chocardiographic analysis of anti-CD28 or control IgG treated mice on day 7 after myocardial infarction (MI) or sham surgery </a:t>
            </a:r>
            <a:r>
              <a:rPr kumimoji="0" lang="en-US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(</a:t>
            </a:r>
            <a:r>
              <a:rPr kumimoji="0" lang="en-US" altLang="de-DE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=5 IgG MI, n=10 anti-CD28 MI, n=5 IgG sham, n=5 anti-CD28 sham</a:t>
            </a:r>
            <a:r>
              <a:rPr kumimoji="0" lang="en-US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; </a:t>
            </a:r>
            <a:r>
              <a:rPr kumimoji="0" lang="en-US" altLang="de-DE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means</a:t>
            </a:r>
            <a:r>
              <a:rPr kumimoji="0" lang="en-US" altLang="de-DE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  <a:sym typeface="Symbol" pitchFamily="18" charset="2"/>
              </a:rPr>
              <a:t></a:t>
            </a:r>
            <a:r>
              <a:rPr kumimoji="0" lang="en-US" altLang="de-DE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SEM</a:t>
            </a:r>
            <a:r>
              <a:rPr kumimoji="0" lang="en-US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). End-systolic area (ESA, mm²), end-diastolic area (EDA, mm²), end-systolic diameter (ESD, mm), end-diastolic diameter (EDD, mm), fractional area change (FAC, %). </a:t>
            </a: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Calibri" pitchFamily="34" charset="0"/>
              <a:cs typeface="Arial" pitchFamily="34" charset="0"/>
              <a:sym typeface="Symbol" pitchFamily="18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4138010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0</Words>
  <Application>Microsoft Office PowerPoint</Application>
  <PresentationFormat>Benutzerdefiniert</PresentationFormat>
  <Paragraphs>6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adine G</dc:creator>
  <cp:lastModifiedBy>Gladow, Nadine</cp:lastModifiedBy>
  <cp:revision>25</cp:revision>
  <dcterms:created xsi:type="dcterms:W3CDTF">2010-01-25T09:18:48Z</dcterms:created>
  <dcterms:modified xsi:type="dcterms:W3CDTF">2020-02-10T07:48:49Z</dcterms:modified>
</cp:coreProperties>
</file>